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8EC6E6-538C-4D32-97CD-948940DF898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A231D2-DE3E-4969-A805-407E1D9A001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6ECD3C-63B1-40F8-9975-4761D72E742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5270CC-942A-437E-A32D-73D86CA328B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76D541-BBF3-40E4-B2D7-306A84CDE71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5A10BE-F98B-4059-8F38-A0BE70E2885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CDDF32-14AE-47BB-A24F-F02D23D018C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802CD3-6ADA-40FC-AF2A-AC458DFBA17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408DEC-75D5-4FF2-B8D5-CCF83A5915B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3B9686-8754-4851-BEC3-B8440D869DD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3B5E2F-9FA0-4E8B-8E92-E2788080625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110ECB-A348-44B0-A103-0085FC76195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E0D88C7-9388-4F2D-9498-6EC6CDA9F4A9}" type="slidenum">
              <a:rPr b="0" lang="zh-CN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152280" y="838080"/>
          <a:ext cx="8763120" cy="5734080"/>
        </p:xfrm>
        <a:graphic>
          <a:graphicData uri="http://schemas.openxmlformats.org/drawingml/2006/table">
            <a:tbl>
              <a:tblPr/>
              <a:tblGrid>
                <a:gridCol w="1067040"/>
                <a:gridCol w="4724280"/>
                <a:gridCol w="2971800"/>
              </a:tblGrid>
              <a:tr h="27324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rimer nam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                 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rimer sequence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             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s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28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3-RTF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AAGCCATCGGTGAGCTTCA</a:t>
                      </a:r>
                      <a:r>
                        <a:rPr b="0" lang="zh-CN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QRT-PCR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324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3-RTR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GCAGCTCTGGCGTAGAATAGC</a:t>
                      </a:r>
                      <a:r>
                        <a:rPr b="0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MS Mincho"/>
                        </a:rPr>
                        <a:t>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QRT-PCR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28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RD29B-RTF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TTGGGAAGAGACTTACCGAC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QRT-PCR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324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RD29B-RTR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CCGTCACACCTTTCTCTTCC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QRT-PCR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28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BF3-RTF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ATACAGACGCAGGAGAGGC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QRT-PCR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324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BF3-RTR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GTATAAGCTTGCTTGCGA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QRT-PCR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28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BF3-EF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AAAATGGGGTCTAGATTAAAC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loning full length ABF3 ORF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324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BF3-ER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CTCTGTCAAATCCGCCAC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loning full length ABF3 ORF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28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3-PDF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ACCTAACGGGGTTCCCTATTTCC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tNCED3 promoter deletion analysi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324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3-PDF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ACCGTGTGAAAGGTCTCAAGTC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tNCED3 promoter deletion analysi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28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3-PDF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ACCGGACCCATGGCCATATACAC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tNCED3 promoter deletion analysi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28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3-PDF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ACCGATTAGATGAGATCGCGAA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tNCED3 promoter deletion analysi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324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3-PDF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ACCTAGGGATTCTTCCAATCCG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tNCED3 promoter deletion analysi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28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3-PDR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AAGTGTGTTCAATCA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tNCED3 promoter deletion analysi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324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3-FR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CGGATTGGAAGAATCCCT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tNCED3 promoter deletion analysi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28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3-FR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ACTTGGATTTTAGTTGACGAG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tNCED3 promoter deletion analysi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324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N3-F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CTCGTCAACTAAAATCCAAGTGGTGTGAAAGGTCTCAAGTC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verlap extension PCR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28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N3-R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ACTTGAGACCTTTCACACCACTTGGATTTTAGTTGACGAG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verlap extension PCR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324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N3-F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AGGGATTCTTCCAATCCGAGTGTGAAAGGTCTCAAGTC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verlap extension PCR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28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N3-R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ACTTGAGACCTTTCACACTCGGATTGGAAGAATCCCT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verlap extension PCR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2" name=""/>
          <p:cNvSpPr/>
          <p:nvPr/>
        </p:nvSpPr>
        <p:spPr>
          <a:xfrm>
            <a:off x="67320" y="392040"/>
            <a:ext cx="3245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Table S1. Primers used in this study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3" name=""/>
          <p:cNvGraphicFramePr/>
          <p:nvPr/>
        </p:nvGraphicFramePr>
        <p:xfrm>
          <a:off x="190440" y="971640"/>
          <a:ext cx="8763120" cy="4914720"/>
        </p:xfrm>
        <a:graphic>
          <a:graphicData uri="http://schemas.openxmlformats.org/drawingml/2006/table">
            <a:tbl>
              <a:tblPr/>
              <a:tblGrid>
                <a:gridCol w="1067040"/>
                <a:gridCol w="4724280"/>
                <a:gridCol w="2971800"/>
              </a:tblGrid>
              <a:tr h="2764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35S-F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CTCGTCAACTAAAATCCAAGTGGCAAGACCCTTCCTCTATAT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verlap extension PCR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64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35S-R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TATAGAGGAAGGGTCTTGCCACTTGGATTTTAGTTGACGAG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verlap extension PCR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64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35S-F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AGGGATTCTTCCAATCCGAGCAAGACCCTTCCTCTATAT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verlap extension PCR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64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35S-R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TATAGAGGAAGGGTCTTGCTCGGATTGGAAGAATCCCT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verlap extension PCR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64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3-PDF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ACCAGCAATCGTGATGGAGGGAA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tNCED3 promoter deletion analysi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64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3-PDF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ACCGCTATCTCCAAAACGTGTCCT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tNCED3 promoter deletion analysi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64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3-PDF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ACCTCGGAGAATAGTGAG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tNCED3 promoter deletion analysi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64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3-PDF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ACCACACCTATAATGTGCA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tNCED3 promoter deletion analysi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64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ABRE-F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AGAAGAATTTCCGGGGTTATATTTGAGAACTCT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utated ABRE amplificatio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64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ABRE-R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AGAGTTCTCAAATATAACCCCGGAAATTCTTCTC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utated ABRE amplificatio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64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5SMP-F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CAAGACCCTTCCTCTATAT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5S minimal promoter amplificatio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64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5SMP-R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AGCGTGTCCTCTCCAAAT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5S minimal promoter amplificatio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64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87R-F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ATGAGGCAAAGACGCGGAGCAATCGTGATGGAGG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verlap extension PCR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64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87R-R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CCTCCATCACGATTGCTCCGCGTCTTTGCCTCAT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verlap extension PCR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64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87N3-F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TTATGAGGCAAAGACGCGGGTGTGAAAGGTCTCAAGTCT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verlap extension PCR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64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87N3-R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GACTTGAGACCTTTCACACCCGCGTCTTTGCCTCATAAC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verlap extension PCR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64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87S-F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TTATGAGGCAAAGACGCGGGCAAGACCCTTCCTCTATAT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verlap extension PCR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64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87S-R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TATAGAGGAAGGGTCTTGCCCGCGTCTTTGCCTCATAAC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verlap extension PCR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8-12T06:41:05Z</dcterms:created>
  <dc:creator>Ding DD</dc:creator>
  <dc:description/>
  <dc:language>en-US</dc:language>
  <cp:lastModifiedBy>CC Ding DD</cp:lastModifiedBy>
  <dcterms:modified xsi:type="dcterms:W3CDTF">2014-01-01T14:31:21Z</dcterms:modified>
  <cp:revision>5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